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2" autoAdjust="0"/>
    <p:restoredTop sz="94660"/>
  </p:normalViewPr>
  <p:slideViewPr>
    <p:cSldViewPr snapToGrid="0">
      <p:cViewPr>
        <p:scale>
          <a:sx n="100" d="100"/>
          <a:sy n="100" d="100"/>
        </p:scale>
        <p:origin x="176" y="-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635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1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6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47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99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570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176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449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75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040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123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CE21F-618C-4FA6-95C3-8370989FA0B8}" type="datetimeFigureOut">
              <a:rPr lang="en-US" smtClean="0"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705119-018D-4D04-98BB-53BFE57B45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6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EFCD491-8D4A-42A3-97E2-9238F92993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5125" y="1767131"/>
            <a:ext cx="6686808" cy="301763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CCE8BA5-245C-4ED8-BEB6-C645675C147E}"/>
              </a:ext>
            </a:extLst>
          </p:cNvPr>
          <p:cNvSpPr txBox="1"/>
          <p:nvPr/>
        </p:nvSpPr>
        <p:spPr>
          <a:xfrm>
            <a:off x="1065125" y="4953221"/>
            <a:ext cx="69875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upplementary Figure S1. Flowchart describing the different sets of materials used in evaluations and predictions over the 3-year experimental period. The 1</a:t>
            </a:r>
            <a:r>
              <a:rPr lang="en-US" sz="1200" baseline="30000" dirty="0"/>
              <a:t>st</a:t>
            </a:r>
            <a:r>
              <a:rPr lang="en-US" sz="1200" dirty="0"/>
              <a:t> year prediction model was  based on 359 accessions, while the year 2 prediction model was based on year 1 data (n=359) and year2 data (n=523).</a:t>
            </a:r>
          </a:p>
        </p:txBody>
      </p:sp>
    </p:spTree>
    <p:extLst>
      <p:ext uri="{BB962C8B-B14F-4D97-AF65-F5344CB8AC3E}">
        <p14:creationId xmlns:p14="http://schemas.microsoft.com/office/powerpoint/2010/main" val="4104421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5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2</cp:revision>
  <dcterms:created xsi:type="dcterms:W3CDTF">2021-04-16T07:52:20Z</dcterms:created>
  <dcterms:modified xsi:type="dcterms:W3CDTF">2021-04-16T09:04:11Z</dcterms:modified>
</cp:coreProperties>
</file>